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0" autoAdjust="0"/>
    <p:restoredTop sz="94660"/>
  </p:normalViewPr>
  <p:slideViewPr>
    <p:cSldViewPr snapToGrid="0">
      <p:cViewPr varScale="1">
        <p:scale>
          <a:sx n="71" d="100"/>
          <a:sy n="71" d="100"/>
        </p:scale>
        <p:origin x="402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C6A621C-225D-4D54-A204-17169D8365AC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C386A3C-1EC4-418B-AAC1-701C24D27E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2778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defTabSz="929579"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445A8AD-DC8C-4561-BA0E-16D091B5CFF6}" type="slidenum">
              <a:rPr lang="en-US" smtClean="0">
                <a:solidFill>
                  <a:prstClr val="black"/>
                </a:solidFill>
              </a:rPr>
              <a:pPr/>
              <a:t>1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66315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33620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7019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67263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7494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94150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68039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65687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9224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03148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95691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91611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74849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02285" y="6488668"/>
            <a:ext cx="109874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prstClr val="black"/>
                </a:solidFill>
              </a:rPr>
              <a:t>Figure S3: </a:t>
            </a:r>
            <a:r>
              <a:rPr lang="en-US" dirty="0" err="1"/>
              <a:t>UpSET-BioTAP</a:t>
            </a:r>
            <a:r>
              <a:rPr lang="en-US" dirty="0"/>
              <a:t> </a:t>
            </a:r>
            <a:r>
              <a:rPr lang="en-US" dirty="0" err="1"/>
              <a:t>ChIP</a:t>
            </a:r>
            <a:r>
              <a:rPr lang="en-US" dirty="0"/>
              <a:t> peaks are enriched for active TSS and transcriptional elongation chromatin signatures</a:t>
            </a:r>
            <a:endParaRPr lang="en-US" dirty="0">
              <a:solidFill>
                <a:prstClr val="black"/>
              </a:solidFill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/>
          <a:srcRect l="25650" t="19499" r="16544" b="15361"/>
          <a:stretch/>
        </p:blipFill>
        <p:spPr>
          <a:xfrm>
            <a:off x="132703" y="1351526"/>
            <a:ext cx="4726547" cy="2994559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/>
          <a:srcRect l="25110" r="24231" b="10828"/>
          <a:stretch/>
        </p:blipFill>
        <p:spPr>
          <a:xfrm>
            <a:off x="5367138" y="317500"/>
            <a:ext cx="6151762" cy="6088118"/>
          </a:xfrm>
          <a:prstGeom prst="rect">
            <a:avLst/>
          </a:prstGeom>
        </p:spPr>
      </p:pic>
      <p:grpSp>
        <p:nvGrpSpPr>
          <p:cNvPr id="27" name="Group 26"/>
          <p:cNvGrpSpPr/>
          <p:nvPr/>
        </p:nvGrpSpPr>
        <p:grpSpPr>
          <a:xfrm>
            <a:off x="7492938" y="3415238"/>
            <a:ext cx="1188720" cy="2377971"/>
            <a:chOff x="7492938" y="3415238"/>
            <a:chExt cx="1188720" cy="2377971"/>
          </a:xfrm>
        </p:grpSpPr>
        <p:cxnSp>
          <p:nvCxnSpPr>
            <p:cNvPr id="11" name="Straight Connector 10"/>
            <p:cNvCxnSpPr/>
            <p:nvPr/>
          </p:nvCxnSpPr>
          <p:spPr>
            <a:xfrm rot="-2700000">
              <a:off x="7492938" y="3415238"/>
              <a:ext cx="1188720" cy="11887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 rot="-2700000">
              <a:off x="7492938" y="3563089"/>
              <a:ext cx="1188720" cy="11887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/>
          </p:nvCxnSpPr>
          <p:spPr>
            <a:xfrm rot="-2700000">
              <a:off x="7492938" y="3712834"/>
              <a:ext cx="1188720" cy="11887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 rot="-2700000">
              <a:off x="7492938" y="3860685"/>
              <a:ext cx="1188720" cy="11887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 rot="-2700000">
              <a:off x="7492938" y="4008536"/>
              <a:ext cx="1188720" cy="11887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 rot="-2700000">
              <a:off x="7492938" y="4307840"/>
              <a:ext cx="1188720" cy="11887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 rot="-2700000">
              <a:off x="7492938" y="4604489"/>
              <a:ext cx="1188720" cy="11887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Rectangle 24"/>
            <p:cNvSpPr/>
            <p:nvPr/>
          </p:nvSpPr>
          <p:spPr>
            <a:xfrm>
              <a:off x="7971292" y="3698545"/>
              <a:ext cx="232012" cy="193798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24" name="Group 23"/>
            <p:cNvGrpSpPr/>
            <p:nvPr/>
          </p:nvGrpSpPr>
          <p:grpSpPr>
            <a:xfrm>
              <a:off x="7937257" y="3874448"/>
              <a:ext cx="300082" cy="1547594"/>
              <a:chOff x="7937257" y="3874448"/>
              <a:chExt cx="300082" cy="1547594"/>
            </a:xfrm>
          </p:grpSpPr>
          <p:sp>
            <p:nvSpPr>
              <p:cNvPr id="7" name="TextBox 6"/>
              <p:cNvSpPr txBox="1"/>
              <p:nvPr/>
            </p:nvSpPr>
            <p:spPr>
              <a:xfrm>
                <a:off x="7937257" y="3874448"/>
                <a:ext cx="300082" cy="369332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n-US" dirty="0"/>
                  <a:t>*</a:t>
                </a: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7937257" y="4026848"/>
                <a:ext cx="300082" cy="369332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n-US" dirty="0"/>
                  <a:t>*</a:t>
                </a: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7937257" y="4163328"/>
                <a:ext cx="300082" cy="369332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n-US" dirty="0"/>
                  <a:t>*</a:t>
                </a: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7937257" y="4327100"/>
                <a:ext cx="300082" cy="369332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n-US" dirty="0"/>
                  <a:t>*</a:t>
                </a: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7937257" y="4477223"/>
                <a:ext cx="300082" cy="369332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n-US" dirty="0"/>
                  <a:t>*</a:t>
                </a: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7937257" y="4766107"/>
                <a:ext cx="300082" cy="369332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n-US" dirty="0"/>
                  <a:t>*</a:t>
                </a: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7937257" y="5052710"/>
                <a:ext cx="300082" cy="369332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n-US" dirty="0"/>
                  <a:t>*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5691379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4</Words>
  <Application>Microsoft Office PowerPoint</Application>
  <PresentationFormat>Widescreen</PresentationFormat>
  <Paragraphs>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lyles</dc:creator>
  <cp:lastModifiedBy>mlyles</cp:lastModifiedBy>
  <cp:revision>3</cp:revision>
  <dcterms:created xsi:type="dcterms:W3CDTF">2016-12-27T20:26:56Z</dcterms:created>
  <dcterms:modified xsi:type="dcterms:W3CDTF">2016-12-27T20:28:36Z</dcterms:modified>
</cp:coreProperties>
</file>